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3" d="100"/>
          <a:sy n="73" d="100"/>
        </p:scale>
        <p:origin x="145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6855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0202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9152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5041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164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403184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64631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2753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7298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37160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8737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4388F3-CFF2-4AE0-B399-0B692C9DC0B4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B81A5F-0BB9-4495-A0BF-202D0588800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5103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EFB43AE8-BABE-42F1-995E-2611BD97A29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996" y="516061"/>
            <a:ext cx="2412000" cy="2203259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EBBC0481-D040-4DF6-A100-0FE9A703BB5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8996" y="2719261"/>
            <a:ext cx="2412000" cy="2248006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999CA0E-DC9B-4916-ABFB-8058F54AAD3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7289" y="516061"/>
            <a:ext cx="2364970" cy="22032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1EB68571-2B0F-4DCC-A568-33E2987E6A0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7289" y="2719261"/>
            <a:ext cx="2412000" cy="229875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867D9172-052F-4A3E-A006-ED192AB4992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5583" y="2719261"/>
            <a:ext cx="2412000" cy="229875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AEC31FF-F0C9-4256-A87C-416FB66966A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65583" y="516061"/>
            <a:ext cx="2412000" cy="2223464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0476F890-415F-FB2B-E75F-BD2B445CEEA1}"/>
              </a:ext>
            </a:extLst>
          </p:cNvPr>
          <p:cNvSpPr txBox="1"/>
          <p:nvPr/>
        </p:nvSpPr>
        <p:spPr>
          <a:xfrm>
            <a:off x="958362" y="5018011"/>
            <a:ext cx="731922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5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inseng adventitious roots treated with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6 h to 120 h, relative to the control roots not treated with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0 h). The expression variations of key enzyme genes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-6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716A53v2_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GT71A27_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S_2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S_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2_4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ginsenoside biosynthesis in the adventitious roots treated with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relative to the control roots. The  “**” asterisk indicates the difference between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and control roots is significant at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≤ 0.01. The remaining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roots not labelled with asterisk are not significantly different from the control roots. 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4120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90</TotalTime>
  <Words>10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P Zhang</dc:creator>
  <cp:lastModifiedBy>MDPI</cp:lastModifiedBy>
  <cp:revision>23</cp:revision>
  <dcterms:created xsi:type="dcterms:W3CDTF">2024-03-29T09:22:11Z</dcterms:created>
  <dcterms:modified xsi:type="dcterms:W3CDTF">2024-07-10T09:23:56Z</dcterms:modified>
</cp:coreProperties>
</file>